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50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787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999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96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365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783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77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447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533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214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920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647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3E7CA9-6ECF-4C0D-AF13-0ACA23F088C5}" type="datetimeFigureOut">
              <a:rPr lang="en-US" smtClean="0"/>
              <a:t>7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ACF268-62FE-4D65-8D15-F8CDD84E7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075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8398" y="196334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S4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714954" y="1086999"/>
            <a:ext cx="155202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/N-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</a:p>
          <a:p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c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Oval 5"/>
          <p:cNvSpPr/>
          <p:nvPr/>
        </p:nvSpPr>
        <p:spPr>
          <a:xfrm>
            <a:off x="3296216" y="892898"/>
            <a:ext cx="1371600" cy="12192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64894" y="129811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77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Oval 7"/>
          <p:cNvSpPr/>
          <p:nvPr/>
        </p:nvSpPr>
        <p:spPr>
          <a:xfrm>
            <a:off x="4191000" y="778598"/>
            <a:ext cx="2286000" cy="1447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76278" y="1085479"/>
            <a:ext cx="145693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2RV1/N-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</a:p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2RV1/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c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109856" y="1307093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997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264956" y="131783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3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4459322" y="1769198"/>
            <a:ext cx="0" cy="9144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1371600" y="2683598"/>
            <a:ext cx="662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1371600" y="2683598"/>
            <a:ext cx="0" cy="3810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650794" y="3140798"/>
            <a:ext cx="17336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p in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N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own in 22RV1/N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16980" y="3104583"/>
            <a:ext cx="16257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p in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N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p in 22RV1/N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092867" y="3140798"/>
            <a:ext cx="17620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wn in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N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p in 22RV1/N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090334" y="3140797"/>
            <a:ext cx="18213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wn in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N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own in 22RV1/N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3429000" y="2683598"/>
            <a:ext cx="0" cy="3810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5867400" y="2686993"/>
            <a:ext cx="0" cy="3810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8000999" y="2686993"/>
            <a:ext cx="0" cy="3810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7776024"/>
              </p:ext>
            </p:extLst>
          </p:nvPr>
        </p:nvGraphicFramePr>
        <p:xfrm>
          <a:off x="838200" y="3750398"/>
          <a:ext cx="876300" cy="23774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6300"/>
              </a:tblGrid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MYC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ANTXR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FSC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CHST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IGSF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CHST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MROH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TNS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CTS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DPY19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PITPNC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CTX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GLI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FF00"/>
                    </a:solidFill>
                  </a:tcPr>
                </a:tc>
              </a:tr>
            </a:tbl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1189049" y="351828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4" name="Table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8989928"/>
              </p:ext>
            </p:extLst>
          </p:nvPr>
        </p:nvGraphicFramePr>
        <p:xfrm>
          <a:off x="6997390" y="3781070"/>
          <a:ext cx="876300" cy="288143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6300"/>
              </a:tblGrid>
              <a:tr h="224558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TLCD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ZBTB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PLEKHH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SERINC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PPM1K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UTR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MYN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CGN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SH3D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ADAM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LMBRD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SCHLAP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FAM105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C1orf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SLC52A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77125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PMEPA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5" name="Table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5985935"/>
              </p:ext>
            </p:extLst>
          </p:nvPr>
        </p:nvGraphicFramePr>
        <p:xfrm>
          <a:off x="7989219" y="3797158"/>
          <a:ext cx="876300" cy="289113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6300"/>
              </a:tblGrid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MAST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HOMER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SPRY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EPHA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SLC2A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TMPRSS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KAT2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MYO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ZNF8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OSBPL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CDYL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DHRS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LPAR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RL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TMEM45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  <a:tr h="18069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F0"/>
                    </a:solidFill>
                  </a:tcPr>
                </a:tc>
              </a:tr>
            </a:tbl>
          </a:graphicData>
        </a:graphic>
      </p:graphicFrame>
      <p:sp>
        <p:nvSpPr>
          <p:cNvPr id="26" name="TextBox 25"/>
          <p:cNvSpPr txBox="1"/>
          <p:nvPr/>
        </p:nvSpPr>
        <p:spPr>
          <a:xfrm>
            <a:off x="7823708" y="352381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Table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5733508"/>
              </p:ext>
            </p:extLst>
          </p:nvPr>
        </p:nvGraphicFramePr>
        <p:xfrm>
          <a:off x="5334000" y="3829856"/>
          <a:ext cx="876300" cy="21945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6300"/>
              </a:tblGrid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BLVRB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GMN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ABCC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RRM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MT1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SEPW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TBC1D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HIST1H2BK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ATP1B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CADPS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SF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AP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00B050"/>
                    </a:solidFill>
                  </a:tcPr>
                </a:tc>
              </a:tr>
            </a:tbl>
          </a:graphicData>
        </a:graphic>
      </p:graphicFrame>
      <p:sp>
        <p:nvSpPr>
          <p:cNvPr id="28" name="TextBox 27"/>
          <p:cNvSpPr txBox="1"/>
          <p:nvPr/>
        </p:nvSpPr>
        <p:spPr>
          <a:xfrm>
            <a:off x="5700387" y="353771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251708" y="356624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0" name="Table 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3350408"/>
              </p:ext>
            </p:extLst>
          </p:nvPr>
        </p:nvGraphicFramePr>
        <p:xfrm>
          <a:off x="2990850" y="3814716"/>
          <a:ext cx="876300" cy="29260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6300"/>
              </a:tblGrid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IGFBP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GABR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GPC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ACAA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MST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PRRT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MST1P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LOC28636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MAMDC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CNTNAP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PLXNB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KIAA16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ARHGAP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PGAM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PAX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ED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solidFill>
                      <a:srgbClr val="FF0000"/>
                    </a:solidFill>
                  </a:tcPr>
                </a:tc>
              </a:tr>
            </a:tbl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7297120" y="2105685"/>
            <a:ext cx="14077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rdenne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t al., 2016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ancer Cell 30, 56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7342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3</Words>
  <Application>Microsoft Office PowerPoint</Application>
  <PresentationFormat>On-screen Show (4:3)</PresentationFormat>
  <Paragraphs>9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uke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iliang Hu</dc:creator>
  <cp:lastModifiedBy>Hailiang Hu</cp:lastModifiedBy>
  <cp:revision>2</cp:revision>
  <dcterms:created xsi:type="dcterms:W3CDTF">2017-04-05T16:18:44Z</dcterms:created>
  <dcterms:modified xsi:type="dcterms:W3CDTF">2017-07-19T17:09:21Z</dcterms:modified>
</cp:coreProperties>
</file>